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73" r:id="rId3"/>
    <p:sldId id="272" r:id="rId4"/>
    <p:sldId id="275" r:id="rId5"/>
    <p:sldId id="278" r:id="rId6"/>
    <p:sldId id="282" r:id="rId7"/>
    <p:sldId id="277" r:id="rId8"/>
  </p:sldIdLst>
  <p:sldSz cx="6858000" cy="9144000" type="letter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104" autoAdjust="0"/>
    <p:restoredTop sz="94660"/>
  </p:normalViewPr>
  <p:slideViewPr>
    <p:cSldViewPr snapToGrid="0">
      <p:cViewPr varScale="1">
        <p:scale>
          <a:sx n="98" d="100"/>
          <a:sy n="98" d="100"/>
        </p:scale>
        <p:origin x="21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fr-FR"/>
              <a:t>Modifier le style des sous-titres du masqu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74962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12617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69572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29612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5142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08709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04556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48961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96144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7692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fr-FR"/>
              <a:t>Cliquez sur l'icône pour ajouter une image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17619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D4CB9A-386A-404B-B176-312302C6E49A}" type="datetimeFigureOut">
              <a:rPr lang="de-CH" smtClean="0"/>
              <a:t>18.08.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33886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/>
          </p:cNvSpPr>
          <p:nvPr/>
        </p:nvSpPr>
        <p:spPr>
          <a:xfrm>
            <a:off x="238634" y="5915509"/>
            <a:ext cx="6466631" cy="961542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51435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475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1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gram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xtur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otyp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-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i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ve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st Linear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bias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dictor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UPs). COL,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lec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634" y="2128436"/>
            <a:ext cx="6480000" cy="3448036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2964284" y="5433365"/>
            <a:ext cx="102870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CH" sz="800" dirty="0">
                <a:latin typeface="Helvetica" panose="020B0604020202020204" pitchFamily="34" charset="0"/>
                <a:cs typeface="Helvetica" panose="020B0604020202020204" pitchFamily="34" charset="0"/>
              </a:rPr>
              <a:t>BLUPs</a:t>
            </a:r>
            <a:endParaRPr 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 rot="16200000">
            <a:off x="-67719" y="3613235"/>
            <a:ext cx="70811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Helvetica" panose="020B0604020202020204" pitchFamily="34" charset="0"/>
                <a:cs typeface="Helvetica" panose="020B0604020202020204" pitchFamily="34" charset="0"/>
              </a:rPr>
              <a:t>Count</a:t>
            </a:r>
            <a:endParaRPr 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2429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/>
          </p:cNvSpPr>
          <p:nvPr/>
        </p:nvSpPr>
        <p:spPr>
          <a:xfrm>
            <a:off x="925178" y="6878887"/>
            <a:ext cx="4648200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51435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475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2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yesia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iter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IC)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criminan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ncipal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nen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st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kely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lec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Low BIC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he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kelihoo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2"/>
          <a:srcRect t="10221"/>
          <a:stretch/>
        </p:blipFill>
        <p:spPr>
          <a:xfrm>
            <a:off x="685800" y="2342147"/>
            <a:ext cx="4887578" cy="43955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33315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78000" y="6410826"/>
            <a:ext cx="62323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oxplot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xtur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otypic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in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tir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ve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st Linear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bias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dictor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UPs)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nc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ignemen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vidual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ve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criminan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ncipal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nen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988" y="1250534"/>
            <a:ext cx="6480000" cy="48340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76995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/>
          </p:cNvSpPr>
          <p:nvPr/>
        </p:nvSpPr>
        <p:spPr>
          <a:xfrm>
            <a:off x="266700" y="5791452"/>
            <a:ext cx="6413500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51435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475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4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ndar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vi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uraci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oss-validation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lec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xtur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-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i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hetic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i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ncipal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nen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C1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2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574" y="1982804"/>
            <a:ext cx="5808239" cy="36025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42943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25600" y="8151935"/>
            <a:ext cx="58143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" pitchFamily="18" charset="0"/>
              </a:rPr>
              <a:t>Figure S5</a:t>
            </a:r>
            <a:r>
              <a:rPr lang="en-US" sz="1200" dirty="0">
                <a:latin typeface="Times" pitchFamily="18" charset="0"/>
              </a:rPr>
              <a:t>. Observed vs. predicted values in predictions for each family on each trait with model A. Each group of six plots depicts predictions for a given trait (given in the title) in all 6 families. Each dot represents one individual.</a:t>
            </a:r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249" y="186940"/>
            <a:ext cx="2969524" cy="1800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3"/>
          <a:srcRect b="255"/>
          <a:stretch/>
        </p:blipFill>
        <p:spPr>
          <a:xfrm>
            <a:off x="143330" y="2136208"/>
            <a:ext cx="2935443" cy="1795404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32761" y="186940"/>
            <a:ext cx="2922376" cy="1800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5"/>
          <a:srcRect l="106" t="171" r="-106" b="426"/>
          <a:stretch/>
        </p:blipFill>
        <p:spPr>
          <a:xfrm>
            <a:off x="3248175" y="2136208"/>
            <a:ext cx="2906962" cy="1789247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6"/>
          <a:srcRect b="448"/>
          <a:stretch/>
        </p:blipFill>
        <p:spPr>
          <a:xfrm>
            <a:off x="167287" y="4085476"/>
            <a:ext cx="2911486" cy="179193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48175" y="4085476"/>
            <a:ext cx="2966385" cy="1800000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7287" y="6034744"/>
            <a:ext cx="2925714" cy="1800000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 rotWithShape="1">
          <a:blip r:embed="rId9"/>
          <a:srcRect t="324"/>
          <a:stretch/>
        </p:blipFill>
        <p:spPr>
          <a:xfrm>
            <a:off x="3232761" y="6040582"/>
            <a:ext cx="2906962" cy="1794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42658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67999" y="6703279"/>
            <a:ext cx="58143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" pitchFamily="18" charset="0"/>
              </a:rPr>
              <a:t>Figure S5 (continued)</a:t>
            </a:r>
            <a:r>
              <a:rPr lang="en-US" sz="1200" dirty="0">
                <a:latin typeface="Times" pitchFamily="18" charset="0"/>
              </a:rPr>
              <a:t>. Observed vs. predicted values in predictions for each family on each trait with model A. Each page depicts predictions for a given trait (given in the title) in all 6 families. Each dot represents one individual.</a:t>
            </a: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/>
          <a:srcRect b="176"/>
          <a:stretch/>
        </p:blipFill>
        <p:spPr>
          <a:xfrm>
            <a:off x="367999" y="466072"/>
            <a:ext cx="2864762" cy="1796837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3"/>
          <a:srcRect b="517"/>
          <a:stretch/>
        </p:blipFill>
        <p:spPr>
          <a:xfrm>
            <a:off x="3374306" y="466072"/>
            <a:ext cx="2853010" cy="179068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 rotWithShape="1">
          <a:blip r:embed="rId4"/>
          <a:srcRect t="407"/>
          <a:stretch/>
        </p:blipFill>
        <p:spPr>
          <a:xfrm>
            <a:off x="367999" y="2472266"/>
            <a:ext cx="2910759" cy="1792669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74306" y="2464936"/>
            <a:ext cx="2914740" cy="18000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3562" y="4463800"/>
            <a:ext cx="2905196" cy="1800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7"/>
          <a:srcRect b="428"/>
          <a:stretch/>
        </p:blipFill>
        <p:spPr>
          <a:xfrm>
            <a:off x="3376215" y="4463800"/>
            <a:ext cx="2912831" cy="1792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32623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99677" y="7711337"/>
            <a:ext cx="627586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6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edness-bas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ncipal-components-bas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ptimiz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ining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dic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mily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ptimiz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od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i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, ALD; B, FNP, C, PC1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, PC2. The legend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li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887" y="1949162"/>
            <a:ext cx="3077419" cy="216000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3306" y="1949162"/>
            <a:ext cx="3049240" cy="21600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3943" y="4472942"/>
            <a:ext cx="3060978" cy="21600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5"/>
          <a:srcRect r="15200"/>
          <a:stretch/>
        </p:blipFill>
        <p:spPr>
          <a:xfrm>
            <a:off x="3243306" y="4472942"/>
            <a:ext cx="3065286" cy="2160000"/>
          </a:xfrm>
          <a:prstGeom prst="rect">
            <a:avLst/>
          </a:prstGeom>
        </p:spPr>
      </p:pic>
      <p:sp>
        <p:nvSpPr>
          <p:cNvPr id="9" name="ZoneTexte 8"/>
          <p:cNvSpPr txBox="1"/>
          <p:nvPr/>
        </p:nvSpPr>
        <p:spPr>
          <a:xfrm>
            <a:off x="-9924" y="1629314"/>
            <a:ext cx="240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A</a:t>
            </a:r>
            <a:endParaRPr lang="en-US" dirty="0"/>
          </a:p>
        </p:txBody>
      </p:sp>
      <p:sp>
        <p:nvSpPr>
          <p:cNvPr id="10" name="ZoneTexte 9"/>
          <p:cNvSpPr txBox="1"/>
          <p:nvPr/>
        </p:nvSpPr>
        <p:spPr>
          <a:xfrm>
            <a:off x="3154606" y="1629314"/>
            <a:ext cx="240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B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-9924" y="4172166"/>
            <a:ext cx="240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C</a:t>
            </a:r>
            <a:endParaRPr lang="en-US" dirty="0"/>
          </a:p>
        </p:txBody>
      </p:sp>
      <p:sp>
        <p:nvSpPr>
          <p:cNvPr id="12" name="ZoneTexte 11"/>
          <p:cNvSpPr txBox="1"/>
          <p:nvPr/>
        </p:nvSpPr>
        <p:spPr>
          <a:xfrm>
            <a:off x="3180743" y="4195018"/>
            <a:ext cx="240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D</a:t>
            </a:r>
            <a:endParaRPr lang="en-US" dirty="0"/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5"/>
          <a:srcRect l="83773" t="36662" b="35590"/>
          <a:stretch/>
        </p:blipFill>
        <p:spPr>
          <a:xfrm>
            <a:off x="299677" y="6632942"/>
            <a:ext cx="822191" cy="8401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03392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4FEC7CDA-A75C-475E-91BB-28D611124670}" vid="{9929A8DE-BDB2-415D-ADFE-DDECAC969A63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4</TotalTime>
  <Words>310</Words>
  <Application>Microsoft Macintosh PowerPoint</Application>
  <PresentationFormat>Format US (216 x 279 mm)</PresentationFormat>
  <Paragraphs>13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Helvetica</vt:lpstr>
      <vt:lpstr>Times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Bundesverwaltung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th Morgane AGROSCOPE</dc:creator>
  <cp:lastModifiedBy>Morgane Roth</cp:lastModifiedBy>
  <cp:revision>44</cp:revision>
  <cp:lastPrinted>2019-12-02T13:12:58Z</cp:lastPrinted>
  <dcterms:created xsi:type="dcterms:W3CDTF">2019-11-19T13:03:52Z</dcterms:created>
  <dcterms:modified xsi:type="dcterms:W3CDTF">2020-08-18T10:19:41Z</dcterms:modified>
</cp:coreProperties>
</file>